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7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commentAuthors.xml" ContentType="application/vnd.openxmlformats-officedocument.presentationml.commentAuthor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5"/>
  </p:notesMasterIdLst>
  <p:sldIdLst>
    <p:sldId id="264" r:id="rId2"/>
    <p:sldId id="265" r:id="rId3"/>
    <p:sldId id="266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ünkel, Anna" initials="DA" lastIdx="1" clrIdx="0">
    <p:extLst>
      <p:ext uri="{19B8F6BF-5375-455C-9EA6-DF929625EA0E}">
        <p15:presenceInfo xmlns:p15="http://schemas.microsoft.com/office/powerpoint/2012/main" userId="S::anna.duenkel@izi.fraunhofer.de::389e6d3e-fe5d-4347-91b8-7bb40b548a3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08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openxmlformats.org/officeDocument/2006/relationships/customXml" Target="../customXml/item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8F3CDD-FBB7-461F-8FF1-EAE4D3D46B6E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C52655-7BBD-4270-8A03-87681012A9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0625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5BC341-8D11-4F89-881E-121CEF51FE6F}" type="datetime1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278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54614-2FA1-4AE4-BF45-42791D1A1634}" type="datetime1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19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E7A-EAFE-4ADB-9888-BA84A54961D5}" type="datetime1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1873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E9DD2-3C24-47DB-A1A4-964F794953A4}" type="datetime1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0909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9DDC40-7C8D-49A2-B030-5BFC76DBF45E}" type="datetime1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8890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F5F81-C0AD-4F70-94A2-BADC2054D9FA}" type="datetime1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6375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3CA-C13E-42BD-954C-43E051B68262}" type="datetime1">
              <a:rPr lang="de-DE" smtClean="0"/>
              <a:t>21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8919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F7A8B-D092-4B12-8F3E-072507581F94}" type="datetime1">
              <a:rPr lang="de-DE" smtClean="0"/>
              <a:t>21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9701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50202-271C-43C4-86C0-656B177376B3}" type="datetime1">
              <a:rPr lang="de-DE" smtClean="0"/>
              <a:t>21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8320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49265-067A-4445-B832-612B57B19D8C}" type="datetime1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286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36824-B1E6-45C4-A4BB-8BABA508A996}" type="datetime1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2393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7BF0E-4F22-49C9-98E9-985E4111F644}" type="datetime1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7443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>
            <a:extLst>
              <a:ext uri="{FF2B5EF4-FFF2-40B4-BE49-F238E27FC236}">
                <a16:creationId xmlns:a16="http://schemas.microsoft.com/office/drawing/2014/main" id="{FD029AC1-BF84-4855-AE95-8CA038C15B8A}"/>
              </a:ext>
            </a:extLst>
          </p:cNvPr>
          <p:cNvSpPr txBox="1"/>
          <p:nvPr/>
        </p:nvSpPr>
        <p:spPr>
          <a:xfrm>
            <a:off x="670355" y="282059"/>
            <a:ext cx="50508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2: Experimental Setup</a:t>
            </a:r>
          </a:p>
        </p:txBody>
      </p:sp>
      <p:sp>
        <p:nvSpPr>
          <p:cNvPr id="6" name="Rectangle 4">
            <a:extLst>
              <a:ext uri="{FF2B5EF4-FFF2-40B4-BE49-F238E27FC236}">
                <a16:creationId xmlns:a16="http://schemas.microsoft.com/office/drawing/2014/main" id="{9B0284FD-16F8-4A6C-B69C-0F08E93936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466" y="9239442"/>
            <a:ext cx="6283068" cy="3847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1: </a:t>
            </a:r>
            <a:r>
              <a:rPr lang="en-US" altLang="de-DE" sz="1100" dirty="0" err="1">
                <a:latin typeface="Arial" panose="020B0604020202020204" pitchFamily="34" charset="0"/>
                <a:ea typeface="Arial" panose="020B0604020202020204" pitchFamily="34" charset="0"/>
              </a:rPr>
              <a:t>Processflowchart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 of NK cell isolation and expansion for Donor 1 to 6 up to 21 days</a:t>
            </a:r>
            <a:endParaRPr kumimoji="0" lang="en-US" altLang="de-DE" sz="1100" i="0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8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131CB879-59DF-45B9-BA80-C19F604A6C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7" y="717354"/>
            <a:ext cx="5845687" cy="8471292"/>
          </a:xfrm>
          <a:prstGeom prst="rect">
            <a:avLst/>
          </a:prstGeom>
        </p:spPr>
      </p:pic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2CDB5C3-29FE-4DA8-83C0-AA8A525ED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5962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>
            <a:extLst>
              <a:ext uri="{FF2B5EF4-FFF2-40B4-BE49-F238E27FC236}">
                <a16:creationId xmlns:a16="http://schemas.microsoft.com/office/drawing/2014/main" id="{FD029AC1-BF84-4855-AE95-8CA038C15B8A}"/>
              </a:ext>
            </a:extLst>
          </p:cNvPr>
          <p:cNvSpPr txBox="1"/>
          <p:nvPr/>
        </p:nvSpPr>
        <p:spPr>
          <a:xfrm>
            <a:off x="670355" y="282059"/>
            <a:ext cx="50508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2: Experimental Setup</a:t>
            </a:r>
          </a:p>
        </p:txBody>
      </p:sp>
      <p:sp>
        <p:nvSpPr>
          <p:cNvPr id="6" name="Rectangle 4">
            <a:extLst>
              <a:ext uri="{FF2B5EF4-FFF2-40B4-BE49-F238E27FC236}">
                <a16:creationId xmlns:a16="http://schemas.microsoft.com/office/drawing/2014/main" id="{9B0284FD-16F8-4A6C-B69C-0F08E93936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465" y="8933332"/>
            <a:ext cx="6283068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2 : </a:t>
            </a:r>
            <a:r>
              <a:rPr lang="en-US" altLang="de-DE" sz="1100" dirty="0" err="1">
                <a:latin typeface="Arial" panose="020B0604020202020204" pitchFamily="34" charset="0"/>
                <a:ea typeface="Arial" panose="020B0604020202020204" pitchFamily="34" charset="0"/>
              </a:rPr>
              <a:t>Processflowchart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 of bag testing with G-Rex 6 as control, Origen </a:t>
            </a:r>
            <a:r>
              <a:rPr lang="en-US" altLang="de-DE" sz="1100" dirty="0" err="1">
                <a:latin typeface="Arial" panose="020B0604020202020204" pitchFamily="34" charset="0"/>
                <a:ea typeface="Arial" panose="020B0604020202020204" pitchFamily="34" charset="0"/>
              </a:rPr>
              <a:t>Permalife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 bag and </a:t>
            </a:r>
            <a:r>
              <a:rPr lang="en-US" altLang="de-DE" sz="1100" dirty="0" err="1">
                <a:latin typeface="Arial" panose="020B0604020202020204" pitchFamily="34" charset="0"/>
                <a:ea typeface="Arial" panose="020B0604020202020204" pitchFamily="34" charset="0"/>
              </a:rPr>
              <a:t>Miltenyi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 Differentiation MACS bag for Donor 1 to 3</a:t>
            </a:r>
            <a:endParaRPr kumimoji="0" lang="en-US" altLang="de-DE" sz="1100" i="0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8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2CDB5C3-29FE-4DA8-83C0-AA8A525ED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2</a:t>
            </a:fld>
            <a:endParaRPr lang="de-DE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9C7ED500-8D7C-452D-B512-D6B0B0A2E3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837" y="900856"/>
            <a:ext cx="6630325" cy="77830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3636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>
            <a:extLst>
              <a:ext uri="{FF2B5EF4-FFF2-40B4-BE49-F238E27FC236}">
                <a16:creationId xmlns:a16="http://schemas.microsoft.com/office/drawing/2014/main" id="{FD029AC1-BF84-4855-AE95-8CA038C15B8A}"/>
              </a:ext>
            </a:extLst>
          </p:cNvPr>
          <p:cNvSpPr txBox="1"/>
          <p:nvPr/>
        </p:nvSpPr>
        <p:spPr>
          <a:xfrm>
            <a:off x="670355" y="282059"/>
            <a:ext cx="50508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2: Experimental Setup</a:t>
            </a:r>
          </a:p>
        </p:txBody>
      </p:sp>
      <p:sp>
        <p:nvSpPr>
          <p:cNvPr id="6" name="Rectangle 4">
            <a:extLst>
              <a:ext uri="{FF2B5EF4-FFF2-40B4-BE49-F238E27FC236}">
                <a16:creationId xmlns:a16="http://schemas.microsoft.com/office/drawing/2014/main" id="{9B0284FD-16F8-4A6C-B69C-0F08E93936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466" y="8757242"/>
            <a:ext cx="6283068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3 : </a:t>
            </a:r>
            <a:r>
              <a:rPr lang="en-US" altLang="de-DE" sz="1100" dirty="0" err="1">
                <a:latin typeface="Arial" panose="020B0604020202020204" pitchFamily="34" charset="0"/>
                <a:ea typeface="Arial" panose="020B0604020202020204" pitchFamily="34" charset="0"/>
              </a:rPr>
              <a:t>Processflowchart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 of shipment testing with G-Rex as control, Origen </a:t>
            </a:r>
            <a:r>
              <a:rPr lang="en-US" altLang="de-DE" sz="1100" dirty="0" err="1">
                <a:latin typeface="Arial" panose="020B0604020202020204" pitchFamily="34" charset="0"/>
                <a:ea typeface="Arial" panose="020B0604020202020204" pitchFamily="34" charset="0"/>
              </a:rPr>
              <a:t>Permalife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 bag in incubator, Origen </a:t>
            </a:r>
            <a:r>
              <a:rPr lang="en-US" altLang="de-DE" sz="1100" dirty="0" err="1">
                <a:latin typeface="Arial" panose="020B0604020202020204" pitchFamily="34" charset="0"/>
                <a:ea typeface="Arial" panose="020B0604020202020204" pitchFamily="34" charset="0"/>
              </a:rPr>
              <a:t>Permalife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 bag in Cellbox™ and cryopreserved for Donor 4 to 6</a:t>
            </a:r>
            <a:endParaRPr kumimoji="0" lang="en-US" altLang="de-DE" sz="1100" i="0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8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2CDB5C3-29FE-4DA8-83C0-AA8A525ED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3</a:t>
            </a:fld>
            <a:endParaRPr lang="de-DE" dirty="0"/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9D77C2F1-535C-42FA-B953-8690337E73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144" y="677986"/>
            <a:ext cx="5419829" cy="8017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5176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786679552C1A8E4993CBF6A23FAB2ED5" ma:contentTypeVersion="4" ma:contentTypeDescription="Ein neues Dokument erstellen." ma:contentTypeScope="" ma:versionID="1242b213505befe49d9e9c581dcaf711">
  <xsd:schema xmlns:xsd="http://www.w3.org/2001/XMLSchema" xmlns:xs="http://www.w3.org/2001/XMLSchema" xmlns:p="http://schemas.microsoft.com/office/2006/metadata/properties" xmlns:ns2="92c20cd1-3e4f-4a24-813b-8bbcc542bd4a" targetNamespace="http://schemas.microsoft.com/office/2006/metadata/properties" ma:root="true" ma:fieldsID="d2993d4b4c0543e65e074508ffe52722" ns2:_="">
    <xsd:import namespace="92c20cd1-3e4f-4a24-813b-8bbcc542bd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c20cd1-3e4f-4a24-813b-8bbcc542bd4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42D1C798-4DAB-463C-A3B4-7781C3651137}"/>
</file>

<file path=customXml/itemProps2.xml><?xml version="1.0" encoding="utf-8"?>
<ds:datastoreItem xmlns:ds="http://schemas.openxmlformats.org/officeDocument/2006/customXml" ds:itemID="{FF35D3E5-1512-467F-9A6B-0BE0ADB5B9CF}"/>
</file>

<file path=customXml/itemProps3.xml><?xml version="1.0" encoding="utf-8"?>
<ds:datastoreItem xmlns:ds="http://schemas.openxmlformats.org/officeDocument/2006/customXml" ds:itemID="{5370DE2C-BD95-4E2F-8F40-AB4E11342205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7</Words>
  <Application>Microsoft Office PowerPoint</Application>
  <PresentationFormat>A4-Papier (210 x 297 mm)</PresentationFormat>
  <Paragraphs>9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ünkel, Anna</dc:creator>
  <cp:lastModifiedBy>Roßbach, Lutz</cp:lastModifiedBy>
  <cp:revision>96</cp:revision>
  <dcterms:created xsi:type="dcterms:W3CDTF">2024-08-07T11:10:13Z</dcterms:created>
  <dcterms:modified xsi:type="dcterms:W3CDTF">2025-01-21T07:06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6679552C1A8E4993CBF6A23FAB2ED5</vt:lpwstr>
  </property>
</Properties>
</file>